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1" r:id="rId2"/>
    <p:sldId id="258" r:id="rId3"/>
    <p:sldId id="259" r:id="rId4"/>
    <p:sldId id="280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  <p:sldId id="279" r:id="rId2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4" d="100"/>
          <a:sy n="104" d="100"/>
        </p:scale>
        <p:origin x="-84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E220A-65C9-4CF4-AC3A-4E8C7B8F3845}" type="datetimeFigureOut">
              <a:rPr lang="en-US" smtClean="0"/>
              <a:t>10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CAFD7-7EA8-4349-BFD3-80989984129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E220A-65C9-4CF4-AC3A-4E8C7B8F3845}" type="datetimeFigureOut">
              <a:rPr lang="en-US" smtClean="0"/>
              <a:t>10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CAFD7-7EA8-4349-BFD3-80989984129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E220A-65C9-4CF4-AC3A-4E8C7B8F3845}" type="datetimeFigureOut">
              <a:rPr lang="en-US" smtClean="0"/>
              <a:t>10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CAFD7-7EA8-4349-BFD3-80989984129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E220A-65C9-4CF4-AC3A-4E8C7B8F3845}" type="datetimeFigureOut">
              <a:rPr lang="en-US" smtClean="0"/>
              <a:t>10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CAFD7-7EA8-4349-BFD3-80989984129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E220A-65C9-4CF4-AC3A-4E8C7B8F3845}" type="datetimeFigureOut">
              <a:rPr lang="en-US" smtClean="0"/>
              <a:t>10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CAFD7-7EA8-4349-BFD3-80989984129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E220A-65C9-4CF4-AC3A-4E8C7B8F3845}" type="datetimeFigureOut">
              <a:rPr lang="en-US" smtClean="0"/>
              <a:t>10/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CAFD7-7EA8-4349-BFD3-80989984129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E220A-65C9-4CF4-AC3A-4E8C7B8F3845}" type="datetimeFigureOut">
              <a:rPr lang="en-US" smtClean="0"/>
              <a:t>10/7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CAFD7-7EA8-4349-BFD3-80989984129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E220A-65C9-4CF4-AC3A-4E8C7B8F3845}" type="datetimeFigureOut">
              <a:rPr lang="en-US" smtClean="0"/>
              <a:t>10/7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CAFD7-7EA8-4349-BFD3-80989984129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E220A-65C9-4CF4-AC3A-4E8C7B8F3845}" type="datetimeFigureOut">
              <a:rPr lang="en-US" smtClean="0"/>
              <a:t>10/7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CAFD7-7EA8-4349-BFD3-80989984129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E220A-65C9-4CF4-AC3A-4E8C7B8F3845}" type="datetimeFigureOut">
              <a:rPr lang="en-US" smtClean="0"/>
              <a:t>10/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CAFD7-7EA8-4349-BFD3-80989984129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E220A-65C9-4CF4-AC3A-4E8C7B8F3845}" type="datetimeFigureOut">
              <a:rPr lang="en-US" smtClean="0"/>
              <a:t>10/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CAFD7-7EA8-4349-BFD3-80989984129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9E220A-65C9-4CF4-AC3A-4E8C7B8F3845}" type="datetimeFigureOut">
              <a:rPr lang="en-US" smtClean="0"/>
              <a:t>10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DCAFD7-7EA8-4349-BFD3-809899841296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5973762"/>
          </a:xfrm>
        </p:spPr>
        <p:txBody>
          <a:bodyPr>
            <a:normAutofit/>
          </a:bodyPr>
          <a:lstStyle/>
          <a:p>
            <a:r>
              <a:rPr lang="en-US" dirty="0" smtClean="0"/>
              <a:t>The Progression of the Influenza Pandemic of 1918-19 Across Indi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2200002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 descr="C:\Users\chandra\Desktop\Population\India Population\Propagation Paper 6\Propagation_Seasonally_Adjusted\Week 09 10-27-1918.b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14141567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 descr="C:\Users\chandra\Desktop\Population\India Population\Propagation Paper 6\Propagation_Seasonally_Adjusted\Week 10 11-03-1918.b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95930568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 descr="C:\Users\chandra\Desktop\Population\India Population\Propagation Paper 6\Propagation_Seasonally_Adjusted\Week 11 11-10-1918.b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3716026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 descr="C:\Users\chandra\Desktop\Population\India Population\Propagation Paper 6\Propagation_Seasonally_Adjusted\Week 12 11-17-1918.b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84515975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 descr="C:\Users\chandra\Desktop\Population\India Population\Propagation Paper 6\Propagation_Seasonally_Adjusted\Week 13 11-24-1918.b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57390123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2" descr="C:\Users\chandra\Desktop\Population\India Population\Propagation Paper 6\Propagation_Seasonally_Adjusted\Week 14 12-01-1918.b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80320342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 descr="C:\Users\chandra\Desktop\Population\India Population\Propagation Paper 6\Propagation_Seasonally_Adjusted\Week 15 12-08-1918.b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08469944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4" name="Picture 2" descr="C:\Users\chandra\Desktop\Population\India Population\Propagation Paper 6\Propagation_Seasonally_Adjusted\Week 16 12-15-1918.b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11231809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2" descr="C:\Users\chandra\Desktop\Population\India Population\Propagation Paper 6\Propagation_Seasonally_Adjusted\Week 17 12-22-1918.b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79240697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Picture 2" descr="C:\Users\chandra\Desktop\Population\India Population\Propagation Paper 6\Propagation_Seasonally_Adjusted\Week 18 12-29-1918.b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81708019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3" descr="C:\Users\chandra\Desktop\Population\India Population\Propagation Paper 6\Propagation_Seasonally_Adjusted\Week 01 09-01-1918.b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20178707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6" name="Picture 2" descr="C:\Users\chandra\Desktop\Population\India Population\Propagation Paper 6\Propagation_Seasonally_Adjusted\Week 19 01-05-1919.b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69269152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30" name="Picture 2" descr="C:\Users\chandra\Desktop\Population\India Population\Propagation Paper 6\Propagation_Seasonally_Adjusted\Week 20 01-12-1919.b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75054623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54" name="Picture 2" descr="C:\Users\chandra\Desktop\Population\India Population\Propagation Paper 6\Propagation_Seasonally_Adjusted\Week 21 01-19-1919.b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57874755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578" name="Picture 2" descr="C:\Users\chandra\Desktop\Population\India Population\Propagation Paper 6\Propagation_Seasonally_Adjusted\Week 22 01-26-1919.b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94650802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048000" y="3139440"/>
            <a:ext cx="281940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400" dirty="0" smtClean="0"/>
              <a:t>The End</a:t>
            </a:r>
            <a:endParaRPr lang="en-US" sz="4400" dirty="0"/>
          </a:p>
        </p:txBody>
      </p:sp>
    </p:spTree>
    <p:extLst>
      <p:ext uri="{BB962C8B-B14F-4D97-AF65-F5344CB8AC3E}">
        <p14:creationId xmlns:p14="http://schemas.microsoft.com/office/powerpoint/2010/main" val="261238159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9" name="Picture 3" descr="C:\Users\chandra\Desktop\Population\India Population\Propagation Paper 6\Propagation_Seasonally_Adjusted\Week 02 09-08-1918.b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30571473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C:\Users\chandra\Desktop\Population\India Population\Propagation Paper 6\Propagation_Seasonally_Adjusted\Week 03 09-15-1918.b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54409792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C:\Users\chandra\Desktop\Population\India Population\Propagation Paper 6\Propagation_Seasonally_Adjusted\Week 04 09-22-1918.b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89190224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 descr="C:\Users\chandra\Desktop\Population\India Population\Propagation Paper 6\Propagation_Seasonally_Adjusted\Week 05 09-29-1918.b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94253845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 descr="C:\Users\chandra\Desktop\Population\India Population\Propagation Paper 6\Propagation_Seasonally_Adjusted\Week 06 10-06-1918.b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10887561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 descr="C:\Users\chandra\Desktop\Population\India Population\Propagation Paper 6\Propagation_Seasonally_Adjusted\Week 07 10-13-1918.b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4821961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 descr="C:\Users\chandra\Desktop\Population\India Population\Propagation Paper 6\Propagation_Seasonally_Adjusted\Week 08 10-20-1918.b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571500"/>
            <a:ext cx="7620000" cy="571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80959367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 advTm="1000">
        <p:fade/>
      </p:transition>
    </mc:Choice>
    <mc:Fallback xmlns="">
      <p:transition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12</Words>
  <Application>Microsoft Office PowerPoint</Application>
  <PresentationFormat>On-screen Show (4:3)</PresentationFormat>
  <Paragraphs>2</Paragraphs>
  <Slides>2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4</vt:i4>
      </vt:variant>
    </vt:vector>
  </HeadingPairs>
  <TitlesOfParts>
    <vt:vector size="25" baseType="lpstr">
      <vt:lpstr>Office Theme</vt:lpstr>
      <vt:lpstr>The Progression of the Influenza Pandemic of 1918-19 Across Indi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International Studies and Program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handr45</dc:creator>
  <cp:lastModifiedBy>Somoza, Jesun</cp:lastModifiedBy>
  <cp:revision>9</cp:revision>
  <dcterms:created xsi:type="dcterms:W3CDTF">2013-05-08T14:56:30Z</dcterms:created>
  <dcterms:modified xsi:type="dcterms:W3CDTF">2014-10-07T08:48:31Z</dcterms:modified>
</cp:coreProperties>
</file>